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866802216350788E-2"/>
          <c:y val="3.8161738921486561E-2"/>
          <c:w val="0.88854082159179859"/>
          <c:h val="0.71940667792580493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Individual onl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Overall (N=485)</c:v>
                </c:pt>
                <c:pt idx="1">
                  <c:v>Never invited (n=110)</c:v>
                </c:pt>
                <c:pt idx="2">
                  <c:v>Newly invited in 2018 (n=132)</c:v>
                </c:pt>
                <c:pt idx="3">
                  <c:v>Invited both in 2017 and 2018 (n=243)</c:v>
                </c:pt>
              </c:strCache>
            </c:strRef>
          </c:cat>
          <c:val>
            <c:numRef>
              <c:f>Sheet1!$B$2:$B$5</c:f>
              <c:numCache>
                <c:formatCode>0</c:formatCode>
                <c:ptCount val="4"/>
                <c:pt idx="0">
                  <c:v>52.4</c:v>
                </c:pt>
                <c:pt idx="1">
                  <c:v>70.900000000000006</c:v>
                </c:pt>
                <c:pt idx="2">
                  <c:v>65.2</c:v>
                </c:pt>
                <c:pt idx="3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A9-4FE1-8B2B-5D8014C919B8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Individual + Family only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Overall (N=485)</c:v>
                </c:pt>
                <c:pt idx="1">
                  <c:v>Never invited (n=110)</c:v>
                </c:pt>
                <c:pt idx="2">
                  <c:v>Newly invited in 2018 (n=132)</c:v>
                </c:pt>
                <c:pt idx="3">
                  <c:v>Invited both in 2017 and 2018 (n=243)</c:v>
                </c:pt>
              </c:strCache>
            </c:strRef>
          </c:cat>
          <c:val>
            <c:numRef>
              <c:f>Sheet1!$C$2:$C$5</c:f>
              <c:numCache>
                <c:formatCode>0</c:formatCode>
                <c:ptCount val="4"/>
                <c:pt idx="0">
                  <c:v>9.9</c:v>
                </c:pt>
                <c:pt idx="1">
                  <c:v>5.5</c:v>
                </c:pt>
                <c:pt idx="2">
                  <c:v>6.8</c:v>
                </c:pt>
                <c:pt idx="3">
                  <c:v>13.6</c:v>
                </c:pt>
              </c:numCache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1-C4A9-4FE1-8B2B-5D8014C919B8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Individual + Community only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Overall (N=485)</c:v>
                </c:pt>
                <c:pt idx="1">
                  <c:v>Never invited (n=110)</c:v>
                </c:pt>
                <c:pt idx="2">
                  <c:v>Newly invited in 2018 (n=132)</c:v>
                </c:pt>
                <c:pt idx="3">
                  <c:v>Invited both in 2017 and 2018 (n=243)</c:v>
                </c:pt>
              </c:strCache>
            </c:strRef>
          </c:cat>
          <c:val>
            <c:numRef>
              <c:f>Sheet1!$D$2:$D$5</c:f>
              <c:numCache>
                <c:formatCode>0</c:formatCode>
                <c:ptCount val="4"/>
                <c:pt idx="0">
                  <c:v>27</c:v>
                </c:pt>
                <c:pt idx="1">
                  <c:v>21.8</c:v>
                </c:pt>
                <c:pt idx="2">
                  <c:v>22</c:v>
                </c:pt>
                <c:pt idx="3">
                  <c:v>32.1</c:v>
                </c:pt>
              </c:numCache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2-C4A9-4FE1-8B2B-5D8014C919B8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All level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5</c:f>
              <c:strCache>
                <c:ptCount val="4"/>
                <c:pt idx="0">
                  <c:v>Overall (N=485)</c:v>
                </c:pt>
                <c:pt idx="1">
                  <c:v>Never invited (n=110)</c:v>
                </c:pt>
                <c:pt idx="2">
                  <c:v>Newly invited in 2018 (n=132)</c:v>
                </c:pt>
                <c:pt idx="3">
                  <c:v>Invited both in 2017 and 2018 (n=243)</c:v>
                </c:pt>
              </c:strCache>
            </c:strRef>
          </c:cat>
          <c:val>
            <c:numRef>
              <c:f>Sheet1!$E$2:$E$5</c:f>
              <c:numCache>
                <c:formatCode>0</c:formatCode>
                <c:ptCount val="4"/>
                <c:pt idx="0">
                  <c:v>10.7</c:v>
                </c:pt>
                <c:pt idx="1">
                  <c:v>1.8</c:v>
                </c:pt>
                <c:pt idx="2">
                  <c:v>6.1</c:v>
                </c:pt>
                <c:pt idx="3">
                  <c:v>17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4A9-4FE1-8B2B-5D8014C919B8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10032159"/>
        <c:axId val="310034239"/>
        <c:extLst/>
      </c:barChart>
      <c:catAx>
        <c:axId val="3100321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0034239"/>
        <c:crosses val="autoZero"/>
        <c:auto val="1"/>
        <c:lblAlgn val="ctr"/>
        <c:lblOffset val="100"/>
        <c:noMultiLvlLbl val="0"/>
      </c:catAx>
      <c:valAx>
        <c:axId val="310034239"/>
        <c:scaling>
          <c:orientation val="minMax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100321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7214</cdr:x>
      <cdr:y>0.03802</cdr:y>
    </cdr:from>
    <cdr:to>
      <cdr:x>0.55132</cdr:x>
      <cdr:y>0.2067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452533" y="206023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C80931-0E1F-44F1-8FDF-E682C1352F48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02F84A-8DB5-4BF1-BB62-52320E60B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95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169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30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58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26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012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02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103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96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924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24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2E815-7C45-4F37-AEE7-4F0AA9A4E59F}" type="datetimeFigureOut">
              <a:rPr lang="en-US" smtClean="0"/>
              <a:t>3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607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1058713876"/>
              </p:ext>
            </p:extLst>
          </p:nvPr>
        </p:nvGraphicFramePr>
        <p:xfrm>
          <a:off x="293511" y="1792705"/>
          <a:ext cx="11548533" cy="4345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5851" y="2815389"/>
            <a:ext cx="461665" cy="92333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dirty="0" smtClean="0"/>
              <a:t>Percen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86869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52</TotalTime>
  <Words>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Mulwa</dc:creator>
  <cp:lastModifiedBy>Sarah Mulwa</cp:lastModifiedBy>
  <cp:revision>208</cp:revision>
  <dcterms:created xsi:type="dcterms:W3CDTF">2019-09-20T09:43:17Z</dcterms:created>
  <dcterms:modified xsi:type="dcterms:W3CDTF">2021-03-14T11:19:44Z</dcterms:modified>
</cp:coreProperties>
</file>